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4C1907-A79E-4E8C-8CC7-2A55C5A45EE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AF8FBA-A169-4D48-B9C5-7931C711A2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18182A-1CE7-4945-BE84-E7F098E82C5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1F49C8-5830-49E5-A3ED-142A4A3BA12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E61D5F-0965-45D0-919F-062725F405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47E890-8B09-4F8D-9964-9BAB71C15F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97AE48-DC68-490E-9652-5FBC410FAE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5801D4-5749-4329-BF2D-4C393FC322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8C22B1-68F8-4BF2-81AD-008D05838C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8CBEC0-8420-4794-B49A-617BBC8653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B84A1D-4855-433A-84D6-C5D5E294A6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252060-5632-48C2-A8F8-B5531F2426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F6B4491-413D-43B8-9131-BCDFE5DEEA0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feld 129"/>
          <p:cNvSpPr/>
          <p:nvPr/>
        </p:nvSpPr>
        <p:spPr>
          <a:xfrm>
            <a:off x="533520" y="1143000"/>
            <a:ext cx="822960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Mitochondrial DNA haplotypic network of the genes COII and ND1 (1311bp) assayed in Western European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Hyalesthes obsoletu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. The haplotype “ab”, connected to the “Pannonian” haplotype “ec”, constitutes the root of the network. The haplotypes “ab” and “bb” are centres of star-like sub-networks, which show signals of demographic expansions in Italy and France/Switzwerland, respectively. The geographic distribution of the haplotypes is presented in Table 2 and Appendix S8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uppierung 132"/>
          <p:cNvGrpSpPr/>
          <p:nvPr/>
        </p:nvGrpSpPr>
        <p:grpSpPr>
          <a:xfrm>
            <a:off x="1630440" y="2637000"/>
            <a:ext cx="6040080" cy="3823200"/>
            <a:chOff x="1630440" y="2637000"/>
            <a:chExt cx="6040080" cy="3823200"/>
          </a:xfrm>
        </p:grpSpPr>
        <p:sp>
          <p:nvSpPr>
            <p:cNvPr id="43" name="Line 162"/>
            <p:cNvSpPr/>
            <p:nvPr/>
          </p:nvSpPr>
          <p:spPr>
            <a:xfrm>
              <a:off x="3832920" y="3822480"/>
              <a:ext cx="609480" cy="35568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Gerade Verbindung 119"/>
            <p:cNvSpPr/>
            <p:nvPr/>
          </p:nvSpPr>
          <p:spPr>
            <a:xfrm>
              <a:off x="3963960" y="3746520"/>
              <a:ext cx="224460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ine 168"/>
            <p:cNvSpPr/>
            <p:nvPr/>
          </p:nvSpPr>
          <p:spPr>
            <a:xfrm flipH="1">
              <a:off x="3875760" y="3475080"/>
              <a:ext cx="1210320" cy="1778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Oval 40"/>
            <p:cNvSpPr/>
            <p:nvPr/>
          </p:nvSpPr>
          <p:spPr>
            <a:xfrm>
              <a:off x="3891240" y="6141240"/>
              <a:ext cx="772200" cy="169200"/>
            </a:xfrm>
            <a:prstGeom prst="ellipse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41"/>
            <p:cNvSpPr/>
            <p:nvPr/>
          </p:nvSpPr>
          <p:spPr>
            <a:xfrm>
              <a:off x="4205520" y="6155280"/>
              <a:ext cx="37368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Lucida Grande"/>
                </a:rPr>
                <a:t>ob 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Oval 42"/>
            <p:cNvSpPr/>
            <p:nvPr/>
          </p:nvSpPr>
          <p:spPr>
            <a:xfrm>
              <a:off x="2425680" y="4880880"/>
              <a:ext cx="772200" cy="169200"/>
            </a:xfrm>
            <a:prstGeom prst="ellipse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43"/>
            <p:cNvSpPr/>
            <p:nvPr/>
          </p:nvSpPr>
          <p:spPr>
            <a:xfrm>
              <a:off x="2737440" y="4892040"/>
              <a:ext cx="34164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Lucida Grande"/>
                </a:rPr>
                <a:t>lb 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Oval 44"/>
            <p:cNvSpPr/>
            <p:nvPr/>
          </p:nvSpPr>
          <p:spPr>
            <a:xfrm>
              <a:off x="3205440" y="5515200"/>
              <a:ext cx="772200" cy="169200"/>
            </a:xfrm>
            <a:prstGeom prst="ellipse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45"/>
            <p:cNvSpPr/>
            <p:nvPr/>
          </p:nvSpPr>
          <p:spPr>
            <a:xfrm>
              <a:off x="3519720" y="5526360"/>
              <a:ext cx="37620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Lucida Grande"/>
                </a:rPr>
                <a:t>bb 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Oval 46"/>
            <p:cNvSpPr/>
            <p:nvPr/>
          </p:nvSpPr>
          <p:spPr>
            <a:xfrm>
              <a:off x="1630440" y="3305880"/>
              <a:ext cx="772200" cy="169200"/>
            </a:xfrm>
            <a:prstGeom prst="ellipse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47"/>
            <p:cNvSpPr/>
            <p:nvPr/>
          </p:nvSpPr>
          <p:spPr>
            <a:xfrm>
              <a:off x="1944720" y="3317040"/>
              <a:ext cx="34164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Lucida Grande"/>
                </a:rPr>
                <a:t>af 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Oval 48"/>
            <p:cNvSpPr/>
            <p:nvPr/>
          </p:nvSpPr>
          <p:spPr>
            <a:xfrm>
              <a:off x="1947240" y="4009320"/>
              <a:ext cx="772200" cy="169200"/>
            </a:xfrm>
            <a:prstGeom prst="ellipse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49"/>
            <p:cNvSpPr/>
            <p:nvPr/>
          </p:nvSpPr>
          <p:spPr>
            <a:xfrm>
              <a:off x="2259000" y="4020480"/>
              <a:ext cx="35892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Lucida Grande"/>
                </a:rPr>
                <a:t>aa 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50"/>
            <p:cNvSpPr/>
            <p:nvPr/>
          </p:nvSpPr>
          <p:spPr>
            <a:xfrm>
              <a:off x="3207240" y="3653280"/>
              <a:ext cx="772200" cy="169200"/>
            </a:xfrm>
            <a:prstGeom prst="rect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51"/>
            <p:cNvSpPr/>
            <p:nvPr/>
          </p:nvSpPr>
          <p:spPr>
            <a:xfrm>
              <a:off x="3519360" y="3664440"/>
              <a:ext cx="36864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Lucida Grande"/>
                </a:rPr>
                <a:t>ab 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Oval 52"/>
            <p:cNvSpPr/>
            <p:nvPr/>
          </p:nvSpPr>
          <p:spPr>
            <a:xfrm>
              <a:off x="2873160" y="3144960"/>
              <a:ext cx="772200" cy="169200"/>
            </a:xfrm>
            <a:prstGeom prst="ellipse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53"/>
            <p:cNvSpPr/>
            <p:nvPr/>
          </p:nvSpPr>
          <p:spPr>
            <a:xfrm>
              <a:off x="3184920" y="3156120"/>
              <a:ext cx="36864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Lucida Grande"/>
                </a:rPr>
                <a:t>ad 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Oval 54"/>
            <p:cNvSpPr/>
            <p:nvPr/>
          </p:nvSpPr>
          <p:spPr>
            <a:xfrm>
              <a:off x="3903120" y="3144960"/>
              <a:ext cx="772200" cy="169200"/>
            </a:xfrm>
            <a:prstGeom prst="ellipse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55"/>
            <p:cNvSpPr/>
            <p:nvPr/>
          </p:nvSpPr>
          <p:spPr>
            <a:xfrm>
              <a:off x="4214880" y="3156120"/>
              <a:ext cx="33660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Lucida Grande"/>
                </a:rPr>
                <a:t>aj 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Oval 56"/>
            <p:cNvSpPr/>
            <p:nvPr/>
          </p:nvSpPr>
          <p:spPr>
            <a:xfrm>
              <a:off x="4883400" y="3356640"/>
              <a:ext cx="772200" cy="169200"/>
            </a:xfrm>
            <a:prstGeom prst="ellipse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57"/>
            <p:cNvSpPr/>
            <p:nvPr/>
          </p:nvSpPr>
          <p:spPr>
            <a:xfrm>
              <a:off x="5244840" y="3367800"/>
              <a:ext cx="34164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Lucida Grande"/>
                </a:rPr>
                <a:t>ib 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Oval 58"/>
            <p:cNvSpPr/>
            <p:nvPr/>
          </p:nvSpPr>
          <p:spPr>
            <a:xfrm>
              <a:off x="4332960" y="4138920"/>
              <a:ext cx="769680" cy="169200"/>
            </a:xfrm>
            <a:prstGeom prst="ellipse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Oval 60"/>
            <p:cNvSpPr/>
            <p:nvPr/>
          </p:nvSpPr>
          <p:spPr>
            <a:xfrm>
              <a:off x="2873160" y="2637000"/>
              <a:ext cx="772200" cy="169200"/>
            </a:xfrm>
            <a:prstGeom prst="ellipse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61"/>
            <p:cNvSpPr/>
            <p:nvPr/>
          </p:nvSpPr>
          <p:spPr>
            <a:xfrm>
              <a:off x="3184920" y="2648160"/>
              <a:ext cx="36360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Lucida Grande"/>
                </a:rPr>
                <a:t>cd 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Oval 62"/>
            <p:cNvSpPr/>
            <p:nvPr/>
          </p:nvSpPr>
          <p:spPr>
            <a:xfrm>
              <a:off x="1739880" y="5607000"/>
              <a:ext cx="772200" cy="169200"/>
            </a:xfrm>
            <a:prstGeom prst="ellipse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63"/>
            <p:cNvSpPr/>
            <p:nvPr/>
          </p:nvSpPr>
          <p:spPr>
            <a:xfrm>
              <a:off x="2051640" y="5621400"/>
              <a:ext cx="37620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Lucida Grande"/>
                </a:rPr>
                <a:t>db 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Oval 64"/>
            <p:cNvSpPr/>
            <p:nvPr/>
          </p:nvSpPr>
          <p:spPr>
            <a:xfrm>
              <a:off x="2673000" y="6118200"/>
              <a:ext cx="772200" cy="169200"/>
            </a:xfrm>
            <a:prstGeom prst="ellipse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65"/>
            <p:cNvSpPr/>
            <p:nvPr/>
          </p:nvSpPr>
          <p:spPr>
            <a:xfrm>
              <a:off x="2987640" y="6129360"/>
              <a:ext cx="37116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Lucida Grande"/>
                </a:rPr>
                <a:t>kb 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Oval 66"/>
            <p:cNvSpPr/>
            <p:nvPr/>
          </p:nvSpPr>
          <p:spPr>
            <a:xfrm>
              <a:off x="4718160" y="5285160"/>
              <a:ext cx="772200" cy="169200"/>
            </a:xfrm>
            <a:prstGeom prst="ellipse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67"/>
            <p:cNvSpPr/>
            <p:nvPr/>
          </p:nvSpPr>
          <p:spPr>
            <a:xfrm>
              <a:off x="5034960" y="5276880"/>
              <a:ext cx="37368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Lucida Grande"/>
                </a:rPr>
                <a:t>nb 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Oval 68"/>
            <p:cNvSpPr/>
            <p:nvPr/>
          </p:nvSpPr>
          <p:spPr>
            <a:xfrm>
              <a:off x="4930560" y="2860200"/>
              <a:ext cx="772200" cy="169200"/>
            </a:xfrm>
            <a:prstGeom prst="ellipse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69"/>
            <p:cNvSpPr/>
            <p:nvPr/>
          </p:nvSpPr>
          <p:spPr>
            <a:xfrm>
              <a:off x="5244840" y="2871360"/>
              <a:ext cx="34164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Lucida Grande"/>
                </a:rPr>
                <a:t>ig 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88"/>
            <p:cNvSpPr/>
            <p:nvPr/>
          </p:nvSpPr>
          <p:spPr>
            <a:xfrm>
              <a:off x="5316480" y="3029760"/>
              <a:ext cx="2160" cy="3387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92"/>
            <p:cNvSpPr/>
            <p:nvPr/>
          </p:nvSpPr>
          <p:spPr>
            <a:xfrm flipV="1">
              <a:off x="2563560" y="3822480"/>
              <a:ext cx="730080" cy="2037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96"/>
            <p:cNvSpPr/>
            <p:nvPr/>
          </p:nvSpPr>
          <p:spPr>
            <a:xfrm flipV="1">
              <a:off x="3259440" y="2805840"/>
              <a:ext cx="2160" cy="3387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106"/>
            <p:cNvSpPr/>
            <p:nvPr/>
          </p:nvSpPr>
          <p:spPr>
            <a:xfrm flipV="1">
              <a:off x="3128760" y="5676120"/>
              <a:ext cx="385920" cy="44208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134"/>
            <p:cNvSpPr/>
            <p:nvPr/>
          </p:nvSpPr>
          <p:spPr>
            <a:xfrm>
              <a:off x="3311280" y="3305880"/>
              <a:ext cx="222480" cy="3474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136"/>
            <p:cNvSpPr/>
            <p:nvPr/>
          </p:nvSpPr>
          <p:spPr>
            <a:xfrm>
              <a:off x="2905920" y="5041440"/>
              <a:ext cx="583920" cy="4737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144"/>
            <p:cNvSpPr/>
            <p:nvPr/>
          </p:nvSpPr>
          <p:spPr>
            <a:xfrm flipH="1" flipV="1">
              <a:off x="2315520" y="3451680"/>
              <a:ext cx="891000" cy="2012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148"/>
            <p:cNvSpPr/>
            <p:nvPr/>
          </p:nvSpPr>
          <p:spPr>
            <a:xfrm>
              <a:off x="3678480" y="5676120"/>
              <a:ext cx="504720" cy="46512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164"/>
            <p:cNvSpPr/>
            <p:nvPr/>
          </p:nvSpPr>
          <p:spPr>
            <a:xfrm flipV="1">
              <a:off x="3704760" y="3305520"/>
              <a:ext cx="472680" cy="3474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200"/>
            <p:cNvSpPr/>
            <p:nvPr/>
          </p:nvSpPr>
          <p:spPr>
            <a:xfrm flipH="1">
              <a:off x="3931200" y="5370840"/>
              <a:ext cx="786600" cy="20088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202"/>
            <p:cNvSpPr/>
            <p:nvPr/>
          </p:nvSpPr>
          <p:spPr>
            <a:xfrm flipH="1" flipV="1">
              <a:off x="3581640" y="3822480"/>
              <a:ext cx="34560" cy="170352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225"/>
            <p:cNvSpPr/>
            <p:nvPr/>
          </p:nvSpPr>
          <p:spPr>
            <a:xfrm flipH="1">
              <a:off x="2494440" y="5615640"/>
              <a:ext cx="720360" cy="5148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" bIns="4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Oval 68"/>
            <p:cNvSpPr/>
            <p:nvPr/>
          </p:nvSpPr>
          <p:spPr>
            <a:xfrm>
              <a:off x="6208920" y="3664440"/>
              <a:ext cx="772200" cy="169200"/>
            </a:xfrm>
            <a:prstGeom prst="ellipse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69"/>
            <p:cNvSpPr/>
            <p:nvPr/>
          </p:nvSpPr>
          <p:spPr>
            <a:xfrm>
              <a:off x="6523200" y="3675600"/>
              <a:ext cx="34164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Lucida Grande"/>
                </a:rPr>
                <a:t>ec 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Oval 58"/>
            <p:cNvSpPr/>
            <p:nvPr/>
          </p:nvSpPr>
          <p:spPr>
            <a:xfrm>
              <a:off x="4690800" y="3675600"/>
              <a:ext cx="162000" cy="131400"/>
            </a:xfrm>
            <a:prstGeom prst="ellipse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440" bIns="46440" anchor="t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Oval 58"/>
            <p:cNvSpPr/>
            <p:nvPr/>
          </p:nvSpPr>
          <p:spPr>
            <a:xfrm>
              <a:off x="5411520" y="3682800"/>
              <a:ext cx="162000" cy="131400"/>
            </a:xfrm>
            <a:prstGeom prst="ellipse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440" bIns="46440" anchor="t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feld 127"/>
            <p:cNvSpPr/>
            <p:nvPr/>
          </p:nvSpPr>
          <p:spPr>
            <a:xfrm>
              <a:off x="6381000" y="3355920"/>
              <a:ext cx="444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roo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feld 128"/>
            <p:cNvSpPr/>
            <p:nvPr/>
          </p:nvSpPr>
          <p:spPr>
            <a:xfrm>
              <a:off x="6258240" y="3862440"/>
              <a:ext cx="1412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Hungary/Romani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67"/>
            <p:cNvSpPr/>
            <p:nvPr/>
          </p:nvSpPr>
          <p:spPr>
            <a:xfrm>
              <a:off x="4657320" y="4131720"/>
              <a:ext cx="378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Lucida Grande"/>
                </a:rPr>
                <a:t>tb 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4" name="Textfeld 133"/>
          <p:cNvSpPr/>
          <p:nvPr/>
        </p:nvSpPr>
        <p:spPr>
          <a:xfrm>
            <a:off x="458640" y="293760"/>
            <a:ext cx="8533080" cy="51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Appendix S9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Johannesen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J, Foissac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X, Kehrli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, Maixner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M: Impact of vector dispersal and host-plant fidelity on the dissemination of an emerging plant pathogen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17T09:25:47Z</dcterms:created>
  <dc:creator>jesjo</dc:creator>
  <dc:description/>
  <dc:language>en-US</dc:language>
  <cp:lastModifiedBy>jesjo</cp:lastModifiedBy>
  <dcterms:modified xsi:type="dcterms:W3CDTF">2012-11-23T10:19:31Z</dcterms:modified>
  <cp:revision>9</cp:revision>
  <dc:subject/>
  <dc:title>Folie 1</dc:title>
</cp:coreProperties>
</file>